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70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405"/>
  </p:normalViewPr>
  <p:slideViewPr>
    <p:cSldViewPr snapToGrid="0" snapToObjects="1">
      <p:cViewPr varScale="1">
        <p:scale>
          <a:sx n="131" d="100"/>
          <a:sy n="131" d="100"/>
        </p:scale>
        <p:origin x="1624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EC7FFEA-CB07-474D-A509-9022E41B8C8A}" type="datetimeFigureOut">
              <a:rPr lang="de-DE" smtClean="0"/>
              <a:t>14.01.21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A5A4BEC-D241-9C4E-A91F-CB0A40D575E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469552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de-DE" dirty="0" err="1"/>
              <a:t>Figure</a:t>
            </a:r>
            <a:r>
              <a:rPr lang="de-DE" dirty="0"/>
              <a:t> S4 </a:t>
            </a:r>
            <a:r>
              <a:rPr lang="de-DE" dirty="0" err="1"/>
              <a:t>sequence</a:t>
            </a:r>
            <a:r>
              <a:rPr lang="de-DE" dirty="0"/>
              <a:t> </a:t>
            </a:r>
            <a:r>
              <a:rPr lang="de-DE" dirty="0" err="1"/>
              <a:t>of</a:t>
            </a:r>
            <a:r>
              <a:rPr lang="de-DE" dirty="0"/>
              <a:t> 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lvC</a:t>
            </a:r>
            <a:r>
              <a:rPr lang="en-US" sz="1200" kern="1200" baseline="300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ADH</a:t>
            </a:r>
            <a:r>
              <a:rPr lang="de-DE" dirty="0">
                <a:effectLst/>
              </a:rPr>
              <a:t> </a:t>
            </a:r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EC6031F-D7BD-EF4F-B1A2-ED8F3C813212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3040545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8BD220-9D98-DC4E-AE3D-92E167B9A527}" type="datetimeFigureOut">
              <a:rPr lang="de-DE" smtClean="0"/>
              <a:t>14.01.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612DB3-B2B9-8448-91C7-8239CEE249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951589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8BD220-9D98-DC4E-AE3D-92E167B9A527}" type="datetimeFigureOut">
              <a:rPr lang="de-DE" smtClean="0"/>
              <a:t>14.01.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612DB3-B2B9-8448-91C7-8239CEE249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231846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8BD220-9D98-DC4E-AE3D-92E167B9A527}" type="datetimeFigureOut">
              <a:rPr lang="de-DE" smtClean="0"/>
              <a:t>14.01.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612DB3-B2B9-8448-91C7-8239CEE249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231285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8BD220-9D98-DC4E-AE3D-92E167B9A527}" type="datetimeFigureOut">
              <a:rPr lang="de-DE" smtClean="0"/>
              <a:t>14.01.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612DB3-B2B9-8448-91C7-8239CEE249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647192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8BD220-9D98-DC4E-AE3D-92E167B9A527}" type="datetimeFigureOut">
              <a:rPr lang="de-DE" smtClean="0"/>
              <a:t>14.01.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612DB3-B2B9-8448-91C7-8239CEE249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218415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8BD220-9D98-DC4E-AE3D-92E167B9A527}" type="datetimeFigureOut">
              <a:rPr lang="de-DE" smtClean="0"/>
              <a:t>14.01.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612DB3-B2B9-8448-91C7-8239CEE249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008109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8BD220-9D98-DC4E-AE3D-92E167B9A527}" type="datetimeFigureOut">
              <a:rPr lang="de-DE" smtClean="0"/>
              <a:t>14.01.21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612DB3-B2B9-8448-91C7-8239CEE249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38375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8BD220-9D98-DC4E-AE3D-92E167B9A527}" type="datetimeFigureOut">
              <a:rPr lang="de-DE" smtClean="0"/>
              <a:t>14.01.21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612DB3-B2B9-8448-91C7-8239CEE249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053478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8BD220-9D98-DC4E-AE3D-92E167B9A527}" type="datetimeFigureOut">
              <a:rPr lang="de-DE" smtClean="0"/>
              <a:t>14.01.21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612DB3-B2B9-8448-91C7-8239CEE249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744567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8BD220-9D98-DC4E-AE3D-92E167B9A527}" type="datetimeFigureOut">
              <a:rPr lang="de-DE" smtClean="0"/>
              <a:t>14.01.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612DB3-B2B9-8448-91C7-8239CEE249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877224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8BD220-9D98-DC4E-AE3D-92E167B9A527}" type="datetimeFigureOut">
              <a:rPr lang="de-DE" smtClean="0"/>
              <a:t>14.01.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612DB3-B2B9-8448-91C7-8239CEE249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552251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8BD220-9D98-DC4E-AE3D-92E167B9A527}" type="datetimeFigureOut">
              <a:rPr lang="de-DE" smtClean="0"/>
              <a:t>14.01.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612DB3-B2B9-8448-91C7-8239CEE249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466156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BED7FECD-1BD1-A944-8F21-0C5312CDE8B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00050" y="868362"/>
            <a:ext cx="7886700" cy="5525294"/>
          </a:xfrm>
        </p:spPr>
        <p:txBody>
          <a:bodyPr>
            <a:normAutofit fontScale="47500" lnSpcReduction="20000"/>
          </a:bodyPr>
          <a:lstStyle/>
          <a:p>
            <a:pPr marL="0" indent="0">
              <a:lnSpc>
                <a:spcPct val="170000"/>
              </a:lnSpc>
              <a:buNone/>
            </a:pPr>
            <a:r>
              <a:rPr lang="en-US" dirty="0"/>
              <a:t>ATGGCAAATTATTTTAATACACTTAATCTTAGACAACAACTTGCACAACTTGGAAAATGTAGATTTATGGGAAGAGATGAATTTGCAGATGGTGCAAGTTATCTTCAGGGAAAAAAAGTTGTTATAGTTGGATGTGGTGCACAAGGACTTAATCAGGGACTTAATATGAGAGATAGTGGACTTGATATAAGTTATGCACTTAGAAAAGAAAGTATAGCAGAAAAAGATGCAGATTGGAGAAAAGCAACAGAAAATGGATTTAAAGTTGGAACATATGAAGAATTAATACCTCAAGCAGATCTTGTTATAAATCTTACACCTGATAAAGTTCATTCAGATGTTGTTAGAACAGTTCAACCTCTTATGAAAGATGGTGCTGCACTTGGATATAGTCATGGTTTTAATATAGTTGAAGTTGGAGAACAAATAAGAAAGGGAATAACAGTTGTAATGGTTGCACCTAAATGTCCTGGAACAGAAGTTAGAGAAGAGTATAAGAGAGGATTTGGAGTTCCTACACTTATAGCAGTTCATCCTGAAAATGATCCTAAAAGAGAAGGTATGGCAATAGCAAAAGCATGGGCAGCAGCAACAGGTGGACATAGAGCTGGTGTTTTAGAAAGTAGTTTTGTTGCAGAAGTTAAATCAGATCTTATGGGAGAACAGACAATACTTTGTGGAATGCTTCAAGCAGGATCACTTCTTTGCTTTGATAAGCTTGTTGAAGAGGGAACTGATCCAGCATATGCAGAAAAGCTTATACAGTTTGGATGGGAAACAATAACAGAAGCACTTAAACAAGGTGGAATAACACTTATGATGGATAGACTTAGCAATCCTGCAAAGTTAAGAGCTTATGCTCTTTCAGAGCAACTTAAAGAAATAATGGCACCTCTTTTTCAAAAACATATGGATGATATAATAAGCGGAGAATTTAGTAGTGGAATGATGGCAGATTGGGCAAATGATGATAAAAAACTTCTTACTTGGAGAGAAGAAACTGGAAAAACAGCATTTGAAACAGCACCTCAATATGAGGGAAAGATAGGTGAGCAAGAATATTTTGATAAAGGTGTTCTTATGATAGCAATGGTTAAGGCTGGTGTTGAACTTGCATTTGAGACAATGGTTGATAGTGGAATAATAGAAGAAAGTGCATATTATGAATCACTTCATGAATTACCTCTTATAGCAAATACAATTGCAAGAAAAAGACTTTATGAAATGAATGTTGTTATAAGTGATACAGCAGAATATGGAAATTATCTTTTTAGTTATGCATGTGTTCCTTTACTTGAACCTTTTATGGCAGAACTTCAACCTGGTGATCTTGGAAAAGCAATACCTGAAGGTGCAGTTGATAATGGACAACTTAGAGATGTTAATGAAGCAATAAGAAGTCATGCAATAGAACAAGTTGGAAAAAAGCTTAGAGGATATATGACAGATATGAAAAGAATAGCAGTTGCAGGATAA</a:t>
            </a:r>
            <a:endParaRPr lang="de-DE" dirty="0"/>
          </a:p>
          <a:p>
            <a:pPr marL="0" indent="0">
              <a:buNone/>
            </a:pP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1627013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7</Words>
  <Application>Microsoft Macintosh PowerPoint</Application>
  <PresentationFormat>Bildschirmpräsentation (4:3)</PresentationFormat>
  <Paragraphs>3</Paragraphs>
  <Slides>1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icrosoft Office User</dc:creator>
  <cp:lastModifiedBy>Microsoft Office User</cp:lastModifiedBy>
  <cp:revision>5</cp:revision>
  <dcterms:created xsi:type="dcterms:W3CDTF">2021-01-14T14:05:53Z</dcterms:created>
  <dcterms:modified xsi:type="dcterms:W3CDTF">2021-01-14T14:34:39Z</dcterms:modified>
</cp:coreProperties>
</file>